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bin" ContentType="application/vnd.openxmlformats-officedocument.oleObject"/>
  <Override PartName="/ppt/notesSlides/notesSlide2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88" r:id="rId2"/>
    <p:sldId id="259" r:id="rId3"/>
    <p:sldId id="29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69" autoAdjust="0"/>
    <p:restoredTop sz="92098" autoAdjust="0"/>
  </p:normalViewPr>
  <p:slideViewPr>
    <p:cSldViewPr>
      <p:cViewPr varScale="1">
        <p:scale>
          <a:sx n="100" d="100"/>
          <a:sy n="100" d="100"/>
        </p:scale>
        <p:origin x="-282" y="-3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image" Target="../media/image6.emf"/><Relationship Id="rId4" Type="http://schemas.openxmlformats.org/officeDocument/2006/relationships/image" Target="../media/image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0B4201-B780-4BE6-ABEF-461FDF29C146}" type="datetimeFigureOut">
              <a:rPr lang="en-US" smtClean="0"/>
              <a:pPr/>
              <a:t>4/13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98AAD6-B236-4098-897D-D70DA2CD775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625567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#: compare grey line to BL for </a:t>
            </a:r>
            <a:r>
              <a:rPr lang="en-US" dirty="0" err="1" smtClean="0"/>
              <a:t>NS+I+Sal</a:t>
            </a:r>
            <a:endParaRPr lang="en-US" dirty="0" smtClean="0"/>
          </a:p>
          <a:p>
            <a:r>
              <a:rPr lang="en-US" dirty="0" smtClean="0"/>
              <a:t>*: compare</a:t>
            </a:r>
            <a:r>
              <a:rPr lang="en-US" baseline="0" dirty="0" smtClean="0"/>
              <a:t> green line to </a:t>
            </a:r>
            <a:r>
              <a:rPr lang="en-US" baseline="0" smtClean="0"/>
              <a:t>BL for NS+I+CTXB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198AAD6-B236-4098-897D-D70DA2CD775C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76035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98577A-E8E7-4083-874A-32A9F5D9F53A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752562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13C32-79E0-4AB8-B4E9-2A1C869F4399}" type="datetimeFigureOut">
              <a:rPr lang="en-US" smtClean="0"/>
              <a:pPr/>
              <a:t>4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3F68F-D28E-4996-AE5A-2AFEB6A125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108307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13C32-79E0-4AB8-B4E9-2A1C869F4399}" type="datetimeFigureOut">
              <a:rPr lang="en-US" smtClean="0"/>
              <a:pPr/>
              <a:t>4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3F68F-D28E-4996-AE5A-2AFEB6A125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652652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13C32-79E0-4AB8-B4E9-2A1C869F4399}" type="datetimeFigureOut">
              <a:rPr lang="en-US" smtClean="0"/>
              <a:pPr/>
              <a:t>4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3F68F-D28E-4996-AE5A-2AFEB6A125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323083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13C32-79E0-4AB8-B4E9-2A1C869F4399}" type="datetimeFigureOut">
              <a:rPr lang="en-US" smtClean="0"/>
              <a:pPr/>
              <a:t>4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3F68F-D28E-4996-AE5A-2AFEB6A125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17686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13C32-79E0-4AB8-B4E9-2A1C869F4399}" type="datetimeFigureOut">
              <a:rPr lang="en-US" smtClean="0"/>
              <a:pPr/>
              <a:t>4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3F68F-D28E-4996-AE5A-2AFEB6A125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52856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13C32-79E0-4AB8-B4E9-2A1C869F4399}" type="datetimeFigureOut">
              <a:rPr lang="en-US" smtClean="0"/>
              <a:pPr/>
              <a:t>4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3F68F-D28E-4996-AE5A-2AFEB6A125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5866203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13C32-79E0-4AB8-B4E9-2A1C869F4399}" type="datetimeFigureOut">
              <a:rPr lang="en-US" smtClean="0"/>
              <a:pPr/>
              <a:t>4/13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3F68F-D28E-4996-AE5A-2AFEB6A125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83771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13C32-79E0-4AB8-B4E9-2A1C869F4399}" type="datetimeFigureOut">
              <a:rPr lang="en-US" smtClean="0"/>
              <a:pPr/>
              <a:t>4/13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3F68F-D28E-4996-AE5A-2AFEB6A125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752214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13C32-79E0-4AB8-B4E9-2A1C869F4399}" type="datetimeFigureOut">
              <a:rPr lang="en-US" smtClean="0"/>
              <a:pPr/>
              <a:t>4/13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3F68F-D28E-4996-AE5A-2AFEB6A125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6337273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13C32-79E0-4AB8-B4E9-2A1C869F4399}" type="datetimeFigureOut">
              <a:rPr lang="en-US" smtClean="0"/>
              <a:pPr/>
              <a:t>4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3F68F-D28E-4996-AE5A-2AFEB6A125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162598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313C32-79E0-4AB8-B4E9-2A1C869F4399}" type="datetimeFigureOut">
              <a:rPr lang="en-US" smtClean="0"/>
              <a:pPr/>
              <a:t>4/13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A3F68F-D28E-4996-AE5A-2AFEB6A125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5681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313C32-79E0-4AB8-B4E9-2A1C869F4399}" type="datetimeFigureOut">
              <a:rPr lang="en-US" smtClean="0"/>
              <a:pPr/>
              <a:t>4/13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A3F68F-D28E-4996-AE5A-2AFEB6A125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861709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3.bin"/><Relationship Id="rId5" Type="http://schemas.openxmlformats.org/officeDocument/2006/relationships/oleObject" Target="../embeddings/oleObject2.bin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14.png"/><Relationship Id="rId18" Type="http://schemas.openxmlformats.org/officeDocument/2006/relationships/image" Target="../media/image16.png"/><Relationship Id="rId3" Type="http://schemas.openxmlformats.org/officeDocument/2006/relationships/oleObject" Target="../embeddings/oleObject5.bin"/><Relationship Id="rId12" Type="http://schemas.openxmlformats.org/officeDocument/2006/relationships/oleObject" Target="../embeddings/oleObject7.bin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5.png"/><Relationship Id="rId1" Type="http://schemas.openxmlformats.org/officeDocument/2006/relationships/vmlDrawing" Target="../drawings/vmlDrawing2.vml"/><Relationship Id="rId11" Type="http://schemas.openxmlformats.org/officeDocument/2006/relationships/image" Target="../media/image13.png"/><Relationship Id="rId5" Type="http://schemas.openxmlformats.org/officeDocument/2006/relationships/image" Target="../media/image10.png"/><Relationship Id="rId15" Type="http://schemas.microsoft.com/office/2007/relationships/hdphoto" Target="../media/hdphoto2.wdp"/><Relationship Id="rId10" Type="http://schemas.openxmlformats.org/officeDocument/2006/relationships/image" Target="../media/image12.png"/><Relationship Id="rId19" Type="http://schemas.openxmlformats.org/officeDocument/2006/relationships/image" Target="../media/image17.png"/><Relationship Id="rId4" Type="http://schemas.openxmlformats.org/officeDocument/2006/relationships/oleObject" Target="../embeddings/oleObject6.bin"/><Relationship Id="rId9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2286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677822" y="23232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752600" y="3075801"/>
            <a:ext cx="23161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s post-injury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295400" y="228600"/>
            <a:ext cx="21801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chanical test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silateral (injured  RHP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7FD67B0F-A232-45C3-919D-0E9DF27E4D05}"/>
              </a:ext>
            </a:extLst>
          </p:cNvPr>
          <p:cNvSpPr txBox="1"/>
          <p:nvPr/>
        </p:nvSpPr>
        <p:spPr>
          <a:xfrm rot="16200000">
            <a:off x="-559033" y="1766884"/>
            <a:ext cx="21343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w withdrawal threshold (g)</a:t>
            </a:r>
          </a:p>
        </p:txBody>
      </p:sp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1082604992"/>
              </p:ext>
            </p:extLst>
          </p:nvPr>
        </p:nvGraphicFramePr>
        <p:xfrm>
          <a:off x="508151" y="748363"/>
          <a:ext cx="3668713" cy="2490787"/>
        </p:xfrm>
        <a:graphic>
          <a:graphicData uri="http://schemas.openxmlformats.org/presentationml/2006/ole">
            <p:oleObj spid="_x0000_s9882" name="Prism 7" r:id="rId4" imgW="3667982" imgH="2491185" progId="">
              <p:embed/>
            </p:oleObj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1447800" y="2209800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####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126738" y="2071300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####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590800" y="1976968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####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058059" y="1976967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####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5013478" y="242500"/>
            <a:ext cx="3825722" cy="3158699"/>
            <a:chOff x="4708678" y="242500"/>
            <a:chExt cx="3825722" cy="3158699"/>
          </a:xfrm>
        </p:grpSpPr>
        <p:sp>
          <p:nvSpPr>
            <p:cNvPr id="9" name="TextBox 8"/>
            <p:cNvSpPr txBox="1"/>
            <p:nvPr/>
          </p:nvSpPr>
          <p:spPr>
            <a:xfrm>
              <a:off x="5521103" y="242500"/>
              <a:ext cx="240369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chanical test</a:t>
              </a:r>
            </a:p>
            <a:p>
              <a:pPr algn="ctr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alateral (uninjured LHP)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142074" y="3124200"/>
              <a:ext cx="23161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s post-injury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7FD67B0F-A232-45C3-919D-0E9DF27E4D05}"/>
                </a:ext>
              </a:extLst>
            </p:cNvPr>
            <p:cNvSpPr txBox="1"/>
            <p:nvPr/>
          </p:nvSpPr>
          <p:spPr>
            <a:xfrm rot="16200000">
              <a:off x="3779994" y="1842317"/>
              <a:ext cx="21343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w withdrawal threshold (g)</a:t>
              </a:r>
            </a:p>
          </p:txBody>
        </p:sp>
        <p:graphicFrame>
          <p:nvGraphicFramePr>
            <p:cNvPr id="20" name="Object 1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xmlns="" val="437503867"/>
                </p:ext>
              </p:extLst>
            </p:nvPr>
          </p:nvGraphicFramePr>
          <p:xfrm>
            <a:off x="4865687" y="764237"/>
            <a:ext cx="3668713" cy="2474913"/>
          </p:xfrm>
          <a:graphic>
            <a:graphicData uri="http://schemas.openxmlformats.org/presentationml/2006/ole">
              <p:oleObj spid="_x0000_s9883" name="Prism 7" r:id="rId5" imgW="3667982" imgH="2474618" progId="">
                <p:embed/>
              </p:oleObj>
            </a:graphicData>
          </a:graphic>
        </p:graphicFrame>
      </p:grp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109197625"/>
              </p:ext>
            </p:extLst>
          </p:nvPr>
        </p:nvGraphicFramePr>
        <p:xfrm>
          <a:off x="508000" y="4191000"/>
          <a:ext cx="4826000" cy="2708275"/>
        </p:xfrm>
        <a:graphic>
          <a:graphicData uri="http://schemas.openxmlformats.org/presentationml/2006/ole">
            <p:oleObj spid="_x0000_s9884" name="Prism 7" r:id="rId6" imgW="4825458" imgH="2707638" progId="">
              <p:embed/>
            </p:oleObj>
          </a:graphicData>
        </a:graphic>
      </p:graphicFrame>
      <p:sp>
        <p:nvSpPr>
          <p:cNvPr id="19" name="TextBox 18"/>
          <p:cNvSpPr txBox="1"/>
          <p:nvPr/>
        </p:nvSpPr>
        <p:spPr>
          <a:xfrm>
            <a:off x="0" y="34290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677822" y="33644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838200" y="3733800"/>
            <a:ext cx="2743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rmal test</a:t>
            </a:r>
          </a:p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silateral (injured RHP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7FD67B0F-A232-45C3-919D-0E9DF27E4D05}"/>
              </a:ext>
            </a:extLst>
          </p:cNvPr>
          <p:cNvSpPr txBox="1"/>
          <p:nvPr/>
        </p:nvSpPr>
        <p:spPr>
          <a:xfrm rot="16200000">
            <a:off x="-387903" y="5188503"/>
            <a:ext cx="19672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w withdrawal latency (s)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692247" y="6532864"/>
            <a:ext cx="23161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s post-injury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438856" y="5834039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####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057400" y="5707038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####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514600" y="5666601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####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012757" y="5657923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####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" name="Group 12"/>
          <p:cNvGrpSpPr/>
          <p:nvPr/>
        </p:nvGrpSpPr>
        <p:grpSpPr>
          <a:xfrm>
            <a:off x="5180383" y="3732528"/>
            <a:ext cx="3743889" cy="2973072"/>
            <a:chOff x="5180383" y="3816824"/>
            <a:chExt cx="3743889" cy="2973072"/>
          </a:xfrm>
        </p:grpSpPr>
        <p:sp>
          <p:nvSpPr>
            <p:cNvPr id="25" name="TextBox 24"/>
            <p:cNvSpPr txBox="1"/>
            <p:nvPr/>
          </p:nvSpPr>
          <p:spPr>
            <a:xfrm>
              <a:off x="6016697" y="3816824"/>
              <a:ext cx="243331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rmal test</a:t>
              </a:r>
            </a:p>
            <a:p>
              <a:pPr algn="ctr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alateral (uninjured LHP)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xmlns="" id="{7FD67B0F-A232-45C3-919D-0E9DF27E4D05}"/>
                </a:ext>
              </a:extLst>
            </p:cNvPr>
            <p:cNvSpPr txBox="1"/>
            <p:nvPr/>
          </p:nvSpPr>
          <p:spPr>
            <a:xfrm rot="16200000">
              <a:off x="4335280" y="5148992"/>
              <a:ext cx="19672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aw withdrawal latency (s)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523074" y="6512897"/>
              <a:ext cx="23161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s post-injury</a:t>
              </a:r>
            </a:p>
          </p:txBody>
        </p:sp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xmlns="" val="1482737361"/>
                </p:ext>
              </p:extLst>
            </p:nvPr>
          </p:nvGraphicFramePr>
          <p:xfrm>
            <a:off x="5255559" y="4145917"/>
            <a:ext cx="3668713" cy="2490787"/>
          </p:xfrm>
          <a:graphic>
            <a:graphicData uri="http://schemas.openxmlformats.org/presentationml/2006/ole">
              <p:oleObj spid="_x0000_s9885" name="Prism 7" r:id="rId7" imgW="3667982" imgH="2491185" progId="">
                <p:embed/>
              </p:oleObj>
            </a:graphicData>
          </a:graphic>
        </p:graphicFrame>
      </p:grpSp>
      <p:sp>
        <p:nvSpPr>
          <p:cNvPr id="32" name="TextBox 31"/>
          <p:cNvSpPr txBox="1"/>
          <p:nvPr/>
        </p:nvSpPr>
        <p:spPr>
          <a:xfrm>
            <a:off x="1501168" y="5438742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*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096285" y="5357626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*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055406" y="5195662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*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568607" y="5298564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*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453604" y="1699403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*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057400" y="1651164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*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2640181" y="158145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113837" y="148728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0" y="-37983"/>
            <a:ext cx="2480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</a:t>
            </a:r>
            <a:r>
              <a:rPr lang="en-US" sz="1400" b="1" dirty="0" smtClean="0"/>
              <a:t>: Figure </a:t>
            </a:r>
            <a:r>
              <a:rPr lang="en-US" sz="1400" b="1" dirty="0" err="1" smtClean="0"/>
              <a:t>S1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xmlns="" val="3901905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1004" y="-52843"/>
            <a:ext cx="3864842" cy="3405643"/>
            <a:chOff x="11004" y="-52843"/>
            <a:chExt cx="3864842" cy="3405643"/>
          </a:xfrm>
        </p:grpSpPr>
        <p:sp>
          <p:nvSpPr>
            <p:cNvPr id="5" name="TextBox 4"/>
            <p:cNvSpPr txBox="1"/>
            <p:nvPr/>
          </p:nvSpPr>
          <p:spPr>
            <a:xfrm>
              <a:off x="11004" y="-52843"/>
              <a:ext cx="248080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ditional file 1</a:t>
              </a:r>
              <a:r>
                <a:rPr lang="en-US" sz="1400" b="1" dirty="0" smtClean="0"/>
                <a:t>: Figure </a:t>
              </a:r>
              <a:r>
                <a:rPr lang="en-US" sz="1400" b="1" dirty="0" err="1" smtClean="0"/>
                <a:t>S2</a:t>
              </a:r>
              <a:r>
                <a:rPr lang="en-US" sz="1400" dirty="0" smtClean="0"/>
                <a:t> </a:t>
              </a:r>
              <a:endParaRPr lang="en-US" sz="1400" dirty="0"/>
            </a:p>
          </p:txBody>
        </p:sp>
        <p:grpSp>
          <p:nvGrpSpPr>
            <p:cNvPr id="2054" name="Group 2053"/>
            <p:cNvGrpSpPr/>
            <p:nvPr/>
          </p:nvGrpSpPr>
          <p:grpSpPr>
            <a:xfrm>
              <a:off x="495300" y="381000"/>
              <a:ext cx="3380546" cy="2971800"/>
              <a:chOff x="152400" y="381000"/>
              <a:chExt cx="3380546" cy="2971800"/>
            </a:xfrm>
          </p:grpSpPr>
          <p:grpSp>
            <p:nvGrpSpPr>
              <p:cNvPr id="2051" name="Group 2050"/>
              <p:cNvGrpSpPr/>
              <p:nvPr/>
            </p:nvGrpSpPr>
            <p:grpSpPr>
              <a:xfrm>
                <a:off x="152400" y="381000"/>
                <a:ext cx="3380546" cy="2809954"/>
                <a:chOff x="3606357" y="3886200"/>
                <a:chExt cx="3380546" cy="2809954"/>
              </a:xfrm>
            </p:grpSpPr>
            <p:pic>
              <p:nvPicPr>
                <p:cNvPr id="1027" name="Picture 3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606357" y="3962400"/>
                  <a:ext cx="3380546" cy="273375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34" name="Rectangle 33"/>
                <p:cNvSpPr/>
                <p:nvPr/>
              </p:nvSpPr>
              <p:spPr>
                <a:xfrm>
                  <a:off x="5029200" y="4038600"/>
                  <a:ext cx="923688" cy="22757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21" name="TextBox 120"/>
                <p:cNvSpPr txBox="1"/>
                <p:nvPr/>
              </p:nvSpPr>
              <p:spPr>
                <a:xfrm>
                  <a:off x="4943005" y="3886200"/>
                  <a:ext cx="100059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ody weight</a:t>
                  </a:r>
                </a:p>
              </p:txBody>
            </p:sp>
            <p:sp>
              <p:nvSpPr>
                <p:cNvPr id="63" name="Rectangle 62"/>
                <p:cNvSpPr/>
                <p:nvPr/>
              </p:nvSpPr>
              <p:spPr>
                <a:xfrm>
                  <a:off x="3721610" y="4973089"/>
                  <a:ext cx="164590" cy="741911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22" name="TextBox 121"/>
                <p:cNvSpPr txBox="1"/>
                <p:nvPr/>
              </p:nvSpPr>
              <p:spPr>
                <a:xfrm rot="16200000">
                  <a:off x="3318862" y="5007122"/>
                  <a:ext cx="87350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Weight (g)</a:t>
                  </a:r>
                </a:p>
              </p:txBody>
            </p:sp>
            <p:sp>
              <p:nvSpPr>
                <p:cNvPr id="2049" name="Rectangle 2048"/>
                <p:cNvSpPr/>
                <p:nvPr/>
              </p:nvSpPr>
              <p:spPr>
                <a:xfrm>
                  <a:off x="4725164" y="4266170"/>
                  <a:ext cx="765880" cy="15343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23" name="TextBox 122"/>
                <p:cNvSpPr txBox="1"/>
                <p:nvPr/>
              </p:nvSpPr>
              <p:spPr>
                <a:xfrm>
                  <a:off x="4612109" y="4218801"/>
                  <a:ext cx="97975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nd of stress</a:t>
                  </a:r>
                </a:p>
              </p:txBody>
            </p:sp>
          </p:grpSp>
          <p:sp>
            <p:nvSpPr>
              <p:cNvPr id="29" name="Rectangle 28"/>
              <p:cNvSpPr/>
              <p:nvPr/>
            </p:nvSpPr>
            <p:spPr>
              <a:xfrm>
                <a:off x="798263" y="2771684"/>
                <a:ext cx="2489730" cy="37687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2053" name="TextBox 2052"/>
              <p:cNvSpPr txBox="1"/>
              <p:nvPr/>
            </p:nvSpPr>
            <p:spPr>
              <a:xfrm>
                <a:off x="1058393" y="2729289"/>
                <a:ext cx="620684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</a:t>
                </a:r>
              </a:p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week)</a:t>
                </a:r>
              </a:p>
            </p:txBody>
          </p:sp>
          <p:sp>
            <p:nvSpPr>
              <p:cNvPr id="124" name="TextBox 123"/>
              <p:cNvSpPr txBox="1"/>
              <p:nvPr/>
            </p:nvSpPr>
            <p:spPr>
              <a:xfrm>
                <a:off x="1966288" y="2706469"/>
                <a:ext cx="1299202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</a:t>
                </a:r>
              </a:p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days post-stress </a:t>
                </a:r>
              </a:p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d injury)</a:t>
                </a:r>
              </a:p>
            </p:txBody>
          </p:sp>
        </p:grpSp>
        <p:sp>
          <p:nvSpPr>
            <p:cNvPr id="2" name="Rectangle 1"/>
            <p:cNvSpPr/>
            <p:nvPr/>
          </p:nvSpPr>
          <p:spPr>
            <a:xfrm>
              <a:off x="3124200" y="1467889"/>
              <a:ext cx="609600" cy="74191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003737" y="1785366"/>
              <a:ext cx="6046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 + I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011090" y="1981292"/>
              <a:ext cx="4940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 + I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995820" y="1432593"/>
              <a:ext cx="4187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 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015082" y="1608767"/>
              <a:ext cx="3080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 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xmlns="" val="31502901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-37983"/>
            <a:ext cx="2480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</a:t>
            </a:r>
            <a:r>
              <a:rPr lang="en-US" sz="1400" b="1" dirty="0" smtClean="0"/>
              <a:t>: Figure </a:t>
            </a:r>
            <a:r>
              <a:rPr lang="en-US" sz="1400" b="1" smtClean="0"/>
              <a:t>S3</a:t>
            </a:r>
            <a:endParaRPr lang="en-US" sz="1400" dirty="0"/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704480388"/>
              </p:ext>
            </p:extLst>
          </p:nvPr>
        </p:nvGraphicFramePr>
        <p:xfrm>
          <a:off x="97804" y="774458"/>
          <a:ext cx="3992563" cy="2725738"/>
        </p:xfrm>
        <a:graphic>
          <a:graphicData uri="http://schemas.openxmlformats.org/presentationml/2006/ole">
            <p:oleObj spid="_x0000_s14704" name="Prism 7" r:id="rId3" imgW="3992825" imgH="2726006" progId="">
              <p:embed/>
            </p:oleObj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0" y="2286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800600" y="33016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972695" y="531911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FC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394686" y="930219"/>
            <a:ext cx="6286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60kD)</a:t>
            </a:r>
          </a:p>
        </p:txBody>
      </p:sp>
      <p:grpSp>
        <p:nvGrpSpPr>
          <p:cNvPr id="11" name="Group 10"/>
          <p:cNvGrpSpPr/>
          <p:nvPr/>
        </p:nvGrpSpPr>
        <p:grpSpPr>
          <a:xfrm>
            <a:off x="1144262" y="759601"/>
            <a:ext cx="2146707" cy="313421"/>
            <a:chOff x="4714751" y="3797096"/>
            <a:chExt cx="2146707" cy="313421"/>
          </a:xfrm>
        </p:grpSpPr>
        <p:sp>
          <p:nvSpPr>
            <p:cNvPr id="12" name="TextBox 11"/>
            <p:cNvSpPr txBox="1"/>
            <p:nvPr/>
          </p:nvSpPr>
          <p:spPr>
            <a:xfrm rot="19562052">
              <a:off x="6099251" y="3802621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 rot="19562052">
              <a:off x="6591832" y="383351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 rot="19562052">
              <a:off x="4714751" y="3797096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 rot="19562052">
              <a:off x="5156662" y="3827994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4845550" y="578535"/>
            <a:ext cx="4038600" cy="2993735"/>
            <a:chOff x="5000004" y="494415"/>
            <a:chExt cx="4038600" cy="2993735"/>
          </a:xfrm>
        </p:grpSpPr>
        <p:graphicFrame>
          <p:nvGraphicFramePr>
            <p:cNvPr id="21" name="Object 20">
              <a:extLst>
                <a:ext uri="{FF2B5EF4-FFF2-40B4-BE49-F238E27FC236}">
                  <a16:creationId xmlns:a16="http://schemas.microsoft.com/office/drawing/2014/main" xmlns="" id="{16F284C7-3292-4BF5-9A99-029BAFED9E0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xmlns="" val="2294705310"/>
                </p:ext>
              </p:extLst>
            </p:nvPr>
          </p:nvGraphicFramePr>
          <p:xfrm>
            <a:off x="5000004" y="716375"/>
            <a:ext cx="4038600" cy="2771775"/>
          </p:xfrm>
          <a:graphic>
            <a:graphicData uri="http://schemas.openxmlformats.org/presentationml/2006/ole">
              <p:oleObj spid="_x0000_s14705" name="Prism 7" r:id="rId4" imgW="4038562" imgH="2771745" progId="">
                <p:embed/>
              </p:oleObj>
            </a:graphicData>
          </a:graphic>
        </p:graphicFrame>
        <p:sp>
          <p:nvSpPr>
            <p:cNvPr id="8" name="TextBox 7"/>
            <p:cNvSpPr txBox="1"/>
            <p:nvPr/>
          </p:nvSpPr>
          <p:spPr>
            <a:xfrm>
              <a:off x="6599854" y="494415"/>
              <a:ext cx="130997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ypothalamus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 rot="19562052">
              <a:off x="7563358" y="743997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 rot="19562052">
              <a:off x="7984977" y="74772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 rot="19562052">
              <a:off x="6216818" y="814681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 rot="19562052">
              <a:off x="6653668" y="83247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8375706" y="985569"/>
              <a:ext cx="62869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en-US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s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60kD)</a:t>
              </a:r>
            </a:p>
          </p:txBody>
        </p:sp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xmlns="" id="{942E6DCA-3605-4056-A03A-5753C4C16EE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 xmlns="">
                    <a14:imgLayer r:embed="rId8">
                      <a14:imgEffect>
                        <a14:sharpenSoften amount="25000"/>
                      </a14:imgEffect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7498435" y="1040657"/>
              <a:ext cx="847725" cy="388862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xmlns="" id="{63A9E57F-FF5F-4205-81BE-80BFC588B44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6129945" y="1070240"/>
              <a:ext cx="847725" cy="334722"/>
            </a:xfrm>
            <a:prstGeom prst="rect">
              <a:avLst/>
            </a:prstGeom>
          </p:spPr>
        </p:pic>
      </p:grpSp>
      <p:pic>
        <p:nvPicPr>
          <p:cNvPr id="24" name="Picture 23">
            <a:extLst>
              <a:ext uri="{FF2B5EF4-FFF2-40B4-BE49-F238E27FC236}">
                <a16:creationId xmlns:a16="http://schemas.microsoft.com/office/drawing/2014/main" xmlns="" id="{9AD79402-CB30-4063-9020-59FBF8F2EF76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2475838" y="1009559"/>
            <a:ext cx="866775" cy="382326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xmlns="" id="{FBA5224E-55AB-4930-8DA5-F6418268ED7C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090225" y="1033516"/>
            <a:ext cx="838200" cy="358368"/>
          </a:xfrm>
          <a:prstGeom prst="rect">
            <a:avLst/>
          </a:prstGeom>
        </p:spPr>
      </p:pic>
      <p:sp>
        <p:nvSpPr>
          <p:cNvPr id="50" name="TextBox 49"/>
          <p:cNvSpPr txBox="1"/>
          <p:nvPr/>
        </p:nvSpPr>
        <p:spPr>
          <a:xfrm>
            <a:off x="-33754" y="366926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4838309" y="366926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grpSp>
        <p:nvGrpSpPr>
          <p:cNvPr id="56" name="Group 55"/>
          <p:cNvGrpSpPr/>
          <p:nvPr/>
        </p:nvGrpSpPr>
        <p:grpSpPr>
          <a:xfrm>
            <a:off x="4872038" y="3936490"/>
            <a:ext cx="4051299" cy="3031048"/>
            <a:chOff x="5092701" y="3785678"/>
            <a:chExt cx="4051299" cy="3031048"/>
          </a:xfrm>
        </p:grpSpPr>
        <p:graphicFrame>
          <p:nvGraphicFramePr>
            <p:cNvPr id="26" name="Object 25">
              <a:extLst>
                <a:ext uri="{FF2B5EF4-FFF2-40B4-BE49-F238E27FC236}">
                  <a16:creationId xmlns:a16="http://schemas.microsoft.com/office/drawing/2014/main" xmlns="" id="{82E8F3C4-D2D3-4A1B-8D93-63EB8A9B380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xmlns="" val="2404355494"/>
                </p:ext>
              </p:extLst>
            </p:nvPr>
          </p:nvGraphicFramePr>
          <p:xfrm>
            <a:off x="5092701" y="4137026"/>
            <a:ext cx="3902075" cy="2679700"/>
          </p:xfrm>
          <a:graphic>
            <a:graphicData uri="http://schemas.openxmlformats.org/presentationml/2006/ole">
              <p:oleObj spid="_x0000_s14706" name="Prism 7" r:id="rId12" imgW="3901350" imgH="2680266" progId="">
                <p:embed/>
              </p:oleObj>
            </a:graphicData>
          </a:graphic>
        </p:graphicFrame>
        <p:grpSp>
          <p:nvGrpSpPr>
            <p:cNvPr id="39" name="Group 38"/>
            <p:cNvGrpSpPr/>
            <p:nvPr/>
          </p:nvGrpSpPr>
          <p:grpSpPr>
            <a:xfrm>
              <a:off x="5923112" y="3785678"/>
              <a:ext cx="3220888" cy="1056035"/>
              <a:chOff x="963181" y="1135213"/>
              <a:chExt cx="3220888" cy="1056035"/>
            </a:xfrm>
          </p:grpSpPr>
          <p:sp>
            <p:nvSpPr>
              <p:cNvPr id="40" name="TextBox 39"/>
              <p:cNvSpPr txBox="1"/>
              <p:nvPr/>
            </p:nvSpPr>
            <p:spPr>
              <a:xfrm rot="19562052">
                <a:off x="963181" y="1533235"/>
                <a:ext cx="3802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</a:p>
            </p:txBody>
          </p:sp>
          <p:grpSp>
            <p:nvGrpSpPr>
              <p:cNvPr id="41" name="Group 40"/>
              <p:cNvGrpSpPr/>
              <p:nvPr/>
            </p:nvGrpSpPr>
            <p:grpSpPr>
              <a:xfrm>
                <a:off x="1347598" y="1135213"/>
                <a:ext cx="2836471" cy="1056035"/>
                <a:chOff x="1347598" y="1135213"/>
                <a:chExt cx="2836471" cy="1056035"/>
              </a:xfrm>
            </p:grpSpPr>
            <p:grpSp>
              <p:nvGrpSpPr>
                <p:cNvPr id="42" name="Group 41"/>
                <p:cNvGrpSpPr/>
                <p:nvPr/>
              </p:nvGrpSpPr>
              <p:grpSpPr>
                <a:xfrm>
                  <a:off x="1347598" y="1135213"/>
                  <a:ext cx="2836471" cy="1056035"/>
                  <a:chOff x="1347598" y="1135213"/>
                  <a:chExt cx="2836471" cy="1056035"/>
                </a:xfrm>
              </p:grpSpPr>
              <p:sp>
                <p:nvSpPr>
                  <p:cNvPr id="44" name="TextBox 43"/>
                  <p:cNvSpPr txBox="1"/>
                  <p:nvPr/>
                </p:nvSpPr>
                <p:spPr>
                  <a:xfrm>
                    <a:off x="1821829" y="1135213"/>
                    <a:ext cx="130997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Hypothalamus</a:t>
                    </a:r>
                  </a:p>
                </p:txBody>
              </p:sp>
              <p:sp>
                <p:nvSpPr>
                  <p:cNvPr id="45" name="TextBox 44"/>
                  <p:cNvSpPr txBox="1"/>
                  <p:nvPr/>
                </p:nvSpPr>
                <p:spPr>
                  <a:xfrm rot="19562052">
                    <a:off x="2777063" y="1508500"/>
                    <a:ext cx="59503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S + I</a:t>
                    </a:r>
                  </a:p>
                </p:txBody>
              </p:sp>
              <p:sp>
                <p:nvSpPr>
                  <p:cNvPr id="46" name="TextBox 45"/>
                  <p:cNvSpPr txBox="1"/>
                  <p:nvPr/>
                </p:nvSpPr>
                <p:spPr>
                  <a:xfrm rot="19562052">
                    <a:off x="3210442" y="1551925"/>
                    <a:ext cx="48442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 + I</a:t>
                    </a:r>
                  </a:p>
                </p:txBody>
              </p:sp>
              <p:sp>
                <p:nvSpPr>
                  <p:cNvPr id="47" name="TextBox 46"/>
                  <p:cNvSpPr txBox="1"/>
                  <p:nvPr/>
                </p:nvSpPr>
                <p:spPr>
                  <a:xfrm rot="19562052">
                    <a:off x="1347598" y="1508500"/>
                    <a:ext cx="59503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S + I</a:t>
                    </a:r>
                  </a:p>
                </p:txBody>
              </p:sp>
              <p:sp>
                <p:nvSpPr>
                  <p:cNvPr id="48" name="TextBox 47"/>
                  <p:cNvSpPr txBox="1"/>
                  <p:nvPr/>
                </p:nvSpPr>
                <p:spPr>
                  <a:xfrm rot="19562052">
                    <a:off x="1790510" y="1518898"/>
                    <a:ext cx="48442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 + I</a:t>
                    </a:r>
                  </a:p>
                </p:txBody>
              </p:sp>
              <p:sp>
                <p:nvSpPr>
                  <p:cNvPr id="49" name="TextBox 48"/>
                  <p:cNvSpPr txBox="1"/>
                  <p:nvPr/>
                </p:nvSpPr>
                <p:spPr>
                  <a:xfrm>
                    <a:off x="3555371" y="1729583"/>
                    <a:ext cx="628698" cy="4616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  <a:r>
                      <a:rPr lang="en-US" sz="12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-</a:t>
                    </a:r>
                    <a:r>
                      <a:rPr lang="en-US" sz="1200" dirty="0" err="1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Fos</a:t>
                    </a:r>
                    <a:endParaRPr 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(60kD)</a:t>
                    </a:r>
                  </a:p>
                </p:txBody>
              </p:sp>
            </p:grpSp>
            <p:sp>
              <p:nvSpPr>
                <p:cNvPr id="43" name="TextBox 42"/>
                <p:cNvSpPr txBox="1"/>
                <p:nvPr/>
              </p:nvSpPr>
              <p:spPr>
                <a:xfrm rot="19562052">
                  <a:off x="2349647" y="1553359"/>
                  <a:ext cx="38023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S</a:t>
                  </a:r>
                </a:p>
              </p:txBody>
            </p:sp>
          </p:grpSp>
        </p:grpSp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xmlns="" id="{79056E8B-CF07-4B1E-A39F-2CBA893A41B0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 xmlns="">
                    <a14:imgLayer r:embed="rId15">
                      <a14:imgEffect>
                        <a14:sharpenSoften amount="25000"/>
                      </a14:imgEffect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7264637" y="4490137"/>
              <a:ext cx="1266825" cy="339909"/>
            </a:xfrm>
            <a:prstGeom prst="rect">
              <a:avLst/>
            </a:prstGeom>
          </p:spPr>
        </p:pic>
        <p:pic>
          <p:nvPicPr>
            <p:cNvPr id="53" name="Picture 52">
              <a:extLst>
                <a:ext uri="{FF2B5EF4-FFF2-40B4-BE49-F238E27FC236}">
                  <a16:creationId xmlns:a16="http://schemas.microsoft.com/office/drawing/2014/main" xmlns="" id="{D72BE001-54A7-42C3-8B74-6AC0E2F43C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990" t="3839"/>
            <a:stretch/>
          </p:blipFill>
          <p:spPr>
            <a:xfrm>
              <a:off x="5876013" y="4494403"/>
              <a:ext cx="1260282" cy="356144"/>
            </a:xfrm>
            <a:prstGeom prst="rect">
              <a:avLst/>
            </a:prstGeom>
          </p:spPr>
        </p:pic>
      </p:grpSp>
      <p:grpSp>
        <p:nvGrpSpPr>
          <p:cNvPr id="2" name="Group 1"/>
          <p:cNvGrpSpPr/>
          <p:nvPr/>
        </p:nvGrpSpPr>
        <p:grpSpPr>
          <a:xfrm>
            <a:off x="121879" y="3849907"/>
            <a:ext cx="4180993" cy="3105351"/>
            <a:chOff x="-68702" y="3725943"/>
            <a:chExt cx="4180993" cy="3105351"/>
          </a:xfrm>
        </p:grpSpPr>
        <p:graphicFrame>
          <p:nvGraphicFramePr>
            <p:cNvPr id="27" name="Object 2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xmlns="" val="415794845"/>
                </p:ext>
              </p:extLst>
            </p:nvPr>
          </p:nvGraphicFramePr>
          <p:xfrm>
            <a:off x="-68702" y="4049994"/>
            <a:ext cx="4057650" cy="2781300"/>
          </p:xfrm>
          <a:graphic>
            <a:graphicData uri="http://schemas.openxmlformats.org/presentationml/2006/ole">
              <p:oleObj spid="_x0000_s14707" name="Prism 7" r:id="rId17" imgW="4056929" imgH="2781109" progId="">
                <p:embed/>
              </p:oleObj>
            </a:graphicData>
          </a:graphic>
        </p:graphicFrame>
        <p:grpSp>
          <p:nvGrpSpPr>
            <p:cNvPr id="28" name="Group 27"/>
            <p:cNvGrpSpPr/>
            <p:nvPr/>
          </p:nvGrpSpPr>
          <p:grpSpPr>
            <a:xfrm>
              <a:off x="849040" y="3725943"/>
              <a:ext cx="3263251" cy="993041"/>
              <a:chOff x="710505" y="1112983"/>
              <a:chExt cx="3263251" cy="993041"/>
            </a:xfrm>
          </p:grpSpPr>
          <p:sp>
            <p:nvSpPr>
              <p:cNvPr id="29" name="TextBox 28"/>
              <p:cNvSpPr txBox="1"/>
              <p:nvPr/>
            </p:nvSpPr>
            <p:spPr>
              <a:xfrm rot="19562052">
                <a:off x="710505" y="1446743"/>
                <a:ext cx="3802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S</a:t>
                </a:r>
              </a:p>
            </p:txBody>
          </p:sp>
          <p:grpSp>
            <p:nvGrpSpPr>
              <p:cNvPr id="30" name="Group 29"/>
              <p:cNvGrpSpPr/>
              <p:nvPr/>
            </p:nvGrpSpPr>
            <p:grpSpPr>
              <a:xfrm>
                <a:off x="1074382" y="1112983"/>
                <a:ext cx="2899374" cy="993041"/>
                <a:chOff x="1074382" y="1112983"/>
                <a:chExt cx="2899374" cy="993041"/>
              </a:xfrm>
            </p:grpSpPr>
            <p:grpSp>
              <p:nvGrpSpPr>
                <p:cNvPr id="31" name="Group 30"/>
                <p:cNvGrpSpPr/>
                <p:nvPr/>
              </p:nvGrpSpPr>
              <p:grpSpPr>
                <a:xfrm>
                  <a:off x="1074382" y="1112983"/>
                  <a:ext cx="2899374" cy="993041"/>
                  <a:chOff x="1074382" y="1112983"/>
                  <a:chExt cx="2899374" cy="993041"/>
                </a:xfrm>
              </p:grpSpPr>
              <p:sp>
                <p:nvSpPr>
                  <p:cNvPr id="33" name="TextBox 32"/>
                  <p:cNvSpPr txBox="1"/>
                  <p:nvPr/>
                </p:nvSpPr>
                <p:spPr>
                  <a:xfrm>
                    <a:off x="1792612" y="1112983"/>
                    <a:ext cx="53251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FC</a:t>
                    </a:r>
                  </a:p>
                </p:txBody>
              </p:sp>
              <p:sp>
                <p:nvSpPr>
                  <p:cNvPr id="34" name="TextBox 33"/>
                  <p:cNvSpPr txBox="1"/>
                  <p:nvPr/>
                </p:nvSpPr>
                <p:spPr>
                  <a:xfrm rot="19562052">
                    <a:off x="2550706" y="1357999"/>
                    <a:ext cx="59503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S + I</a:t>
                    </a:r>
                  </a:p>
                </p:txBody>
              </p:sp>
              <p:sp>
                <p:nvSpPr>
                  <p:cNvPr id="35" name="TextBox 34"/>
                  <p:cNvSpPr txBox="1"/>
                  <p:nvPr/>
                </p:nvSpPr>
                <p:spPr>
                  <a:xfrm rot="19562052">
                    <a:off x="3016493" y="1387300"/>
                    <a:ext cx="48442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 + I</a:t>
                    </a:r>
                  </a:p>
                </p:txBody>
              </p:sp>
              <p:sp>
                <p:nvSpPr>
                  <p:cNvPr id="36" name="TextBox 35"/>
                  <p:cNvSpPr txBox="1"/>
                  <p:nvPr/>
                </p:nvSpPr>
                <p:spPr>
                  <a:xfrm rot="19562052">
                    <a:off x="1074382" y="1387301"/>
                    <a:ext cx="595035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S + I</a:t>
                    </a:r>
                  </a:p>
                </p:txBody>
              </p:sp>
              <p:sp>
                <p:nvSpPr>
                  <p:cNvPr id="37" name="TextBox 36"/>
                  <p:cNvSpPr txBox="1"/>
                  <p:nvPr/>
                </p:nvSpPr>
                <p:spPr>
                  <a:xfrm rot="19562052">
                    <a:off x="1509356" y="1435258"/>
                    <a:ext cx="48442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 + I</a:t>
                    </a:r>
                  </a:p>
                </p:txBody>
              </p:sp>
              <p:sp>
                <p:nvSpPr>
                  <p:cNvPr id="38" name="TextBox 37"/>
                  <p:cNvSpPr txBox="1"/>
                  <p:nvPr/>
                </p:nvSpPr>
                <p:spPr>
                  <a:xfrm>
                    <a:off x="3345058" y="1644359"/>
                    <a:ext cx="628698" cy="46166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  <a:r>
                      <a:rPr lang="en-US" sz="12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-</a:t>
                    </a:r>
                    <a:r>
                      <a:rPr lang="en-US" sz="1200" dirty="0" err="1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Fos</a:t>
                    </a:r>
                    <a:endParaRPr 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r>
                      <a: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(60kD)</a:t>
                    </a:r>
                  </a:p>
                </p:txBody>
              </p:sp>
            </p:grpSp>
            <p:sp>
              <p:nvSpPr>
                <p:cNvPr id="32" name="TextBox 31"/>
                <p:cNvSpPr txBox="1"/>
                <p:nvPr/>
              </p:nvSpPr>
              <p:spPr>
                <a:xfrm rot="19562052">
                  <a:off x="2136996" y="1435256"/>
                  <a:ext cx="38023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S</a:t>
                  </a:r>
                </a:p>
              </p:txBody>
            </p:sp>
          </p:grpSp>
        </p:grpSp>
        <p:pic>
          <p:nvPicPr>
            <p:cNvPr id="54" name="Picture 53">
              <a:extLst>
                <a:ext uri="{FF2B5EF4-FFF2-40B4-BE49-F238E27FC236}">
                  <a16:creationId xmlns:a16="http://schemas.microsoft.com/office/drawing/2014/main" xmlns="" id="{BA6091FF-9084-413B-8586-37D95A88C17F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2204889" y="4340026"/>
              <a:ext cx="1266825" cy="449515"/>
            </a:xfrm>
            <a:prstGeom prst="rect">
              <a:avLst/>
            </a:prstGeom>
          </p:spPr>
        </p:pic>
        <p:pic>
          <p:nvPicPr>
            <p:cNvPr id="55" name="Picture 54">
              <a:extLst>
                <a:ext uri="{FF2B5EF4-FFF2-40B4-BE49-F238E27FC236}">
                  <a16:creationId xmlns:a16="http://schemas.microsoft.com/office/drawing/2014/main" xmlns="" id="{A82A6189-5399-492D-AEB8-1CB8511C71B6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771227" y="4340026"/>
              <a:ext cx="1285875" cy="45993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xmlns="" val="32559644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62</TotalTime>
  <Words>204</Words>
  <Application>Microsoft Office PowerPoint</Application>
  <PresentationFormat>On-screen Show (4:3)</PresentationFormat>
  <Paragraphs>93</Paragraphs>
  <Slides>3</Slides>
  <Notes>2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5" baseType="lpstr">
      <vt:lpstr>Office Theme</vt:lpstr>
      <vt:lpstr>Prism 7</vt:lpstr>
      <vt:lpstr>Slide 1</vt:lpstr>
      <vt:lpstr>Slide 2</vt:lpstr>
      <vt:lpstr>Slide 3</vt:lpstr>
    </vt:vector>
  </TitlesOfParts>
  <Company>MEDCOM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sanya, Natasha M</dc:creator>
  <cp:lastModifiedBy>0003469</cp:lastModifiedBy>
  <cp:revision>765</cp:revision>
  <dcterms:created xsi:type="dcterms:W3CDTF">2017-07-31T20:05:55Z</dcterms:created>
  <dcterms:modified xsi:type="dcterms:W3CDTF">2019-04-13T06:45:14Z</dcterms:modified>
</cp:coreProperties>
</file>